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5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  <a:srgbClr val="0432FF"/>
    <a:srgbClr val="FF0000"/>
    <a:srgbClr val="953735"/>
    <a:srgbClr val="FFCCCB"/>
    <a:srgbClr val="376092"/>
    <a:srgbClr val="FCBE00"/>
    <a:srgbClr val="F8F8F8"/>
    <a:srgbClr val="EFC5AB"/>
    <a:srgbClr val="EDAD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30"/>
    <p:restoredTop sz="96038" autoAdjust="0"/>
  </p:normalViewPr>
  <p:slideViewPr>
    <p:cSldViewPr snapToGrid="0">
      <p:cViewPr varScale="1">
        <p:scale>
          <a:sx n="72" d="100"/>
          <a:sy n="72" d="100"/>
        </p:scale>
        <p:origin x="31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o365jbnu-my.sharepoint.com/personal/pse201955030_student_jbnu_ac_kr/Documents/04.%20&#4354;&#4457;&#4523;&#4358;&#4462;&#4523;/2021.%20&#4355;&#4449;&#4528;&#4364;&#4469;&#4523;&#4355;&#4467;&#4352;&#4469;%20RNA%20seq/00.%20&#4361;&#4457;&#4363;&#4467;&#4523;%20&#4364;&#4449;&#4520;&#4363;&#4453;&#4536;/qPCR-%20result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o365jbnu-my.sharepoint.com/personal/pse201955030_student_jbnu_ac_kr/Documents/04.%20&#4354;&#4457;&#4523;&#4358;&#4462;&#4523;/2021.%20&#4355;&#4449;&#4528;&#4364;&#4469;&#4523;&#4355;&#4467;&#4352;&#4469;%20RNA%20seq/00.%20&#4361;&#4457;&#4363;&#4467;&#4523;%20&#4364;&#4449;&#4520;&#4363;&#4453;&#4536;/qPCR-%20result%20summ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657513748809736E-2"/>
          <c:y val="3.7091347998354916E-2"/>
          <c:w val="0.88800124370858358"/>
          <c:h val="0.884685468289552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M vs IRM'!$E$24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M vs IRM'!$G$25:$G$29</c:f>
                <c:numCache>
                  <c:formatCode>General</c:formatCode>
                  <c:ptCount val="5"/>
                  <c:pt idx="0">
                    <c:v>0.73337697061370732</c:v>
                  </c:pt>
                  <c:pt idx="1">
                    <c:v>0.55769251019280108</c:v>
                  </c:pt>
                  <c:pt idx="2">
                    <c:v>0.30452786905299001</c:v>
                  </c:pt>
                  <c:pt idx="3">
                    <c:v>0.26747439323800104</c:v>
                  </c:pt>
                  <c:pt idx="4">
                    <c:v>0.91209634506937609</c:v>
                  </c:pt>
                </c:numCache>
              </c:numRef>
            </c:plus>
            <c:minus>
              <c:numRef>
                <c:f>'RM vs IRM'!$G$25:$G$29</c:f>
                <c:numCache>
                  <c:formatCode>General</c:formatCode>
                  <c:ptCount val="5"/>
                  <c:pt idx="0">
                    <c:v>0.73337697061370732</c:v>
                  </c:pt>
                  <c:pt idx="1">
                    <c:v>0.55769251019280108</c:v>
                  </c:pt>
                  <c:pt idx="2">
                    <c:v>0.30452786905299001</c:v>
                  </c:pt>
                  <c:pt idx="3">
                    <c:v>0.26747439323800104</c:v>
                  </c:pt>
                  <c:pt idx="4">
                    <c:v>0.912096345069376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M vs IRM'!$B$25:$B$29</c:f>
              <c:strCache>
                <c:ptCount val="5"/>
                <c:pt idx="0">
                  <c:v>RM2</c:v>
                </c:pt>
                <c:pt idx="1">
                  <c:v>RM3</c:v>
                </c:pt>
                <c:pt idx="2">
                  <c:v>RM8</c:v>
                </c:pt>
                <c:pt idx="3">
                  <c:v>RM9</c:v>
                </c:pt>
                <c:pt idx="4">
                  <c:v>RM31</c:v>
                </c:pt>
              </c:strCache>
            </c:strRef>
          </c:cat>
          <c:val>
            <c:numRef>
              <c:f>'RM vs IRM'!$E$25:$E$29</c:f>
              <c:numCache>
                <c:formatCode>General</c:formatCode>
                <c:ptCount val="5"/>
                <c:pt idx="0">
                  <c:v>4.8889064169874699</c:v>
                </c:pt>
                <c:pt idx="1">
                  <c:v>5.0340029546941691</c:v>
                </c:pt>
                <c:pt idx="2">
                  <c:v>2.2072408242012722</c:v>
                </c:pt>
                <c:pt idx="3">
                  <c:v>2.4932710268080043</c:v>
                </c:pt>
                <c:pt idx="4">
                  <c:v>-2.20098311910492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3F-6845-B029-2D009BEDB41B}"/>
            </c:ext>
          </c:extLst>
        </c:ser>
        <c:ser>
          <c:idx val="1"/>
          <c:order val="1"/>
          <c:tx>
            <c:strRef>
              <c:f>'RM vs IRM'!$D$24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RM vs IRM'!$B$25:$B$29</c:f>
              <c:strCache>
                <c:ptCount val="5"/>
                <c:pt idx="0">
                  <c:v>RM2</c:v>
                </c:pt>
                <c:pt idx="1">
                  <c:v>RM3</c:v>
                </c:pt>
                <c:pt idx="2">
                  <c:v>RM8</c:v>
                </c:pt>
                <c:pt idx="3">
                  <c:v>RM9</c:v>
                </c:pt>
                <c:pt idx="4">
                  <c:v>RM31</c:v>
                </c:pt>
              </c:strCache>
            </c:strRef>
          </c:cat>
          <c:val>
            <c:numRef>
              <c:f>'RM vs IRM'!$D$25:$D$29</c:f>
              <c:numCache>
                <c:formatCode>General</c:formatCode>
                <c:ptCount val="5"/>
                <c:pt idx="0">
                  <c:v>5.4939499999999999</c:v>
                </c:pt>
                <c:pt idx="1">
                  <c:v>5.4939499999999999</c:v>
                </c:pt>
                <c:pt idx="2">
                  <c:v>4.9863200000000001</c:v>
                </c:pt>
                <c:pt idx="3">
                  <c:v>4.9863200000000001</c:v>
                </c:pt>
                <c:pt idx="4">
                  <c:v>-2.6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3F-6845-B029-2D009BEDB4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02756800"/>
        <c:axId val="1006016000"/>
      </c:barChart>
      <c:catAx>
        <c:axId val="1002756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006016000"/>
        <c:crosses val="autoZero"/>
        <c:auto val="1"/>
        <c:lblAlgn val="ctr"/>
        <c:lblOffset val="100"/>
        <c:noMultiLvlLbl val="0"/>
      </c:catAx>
      <c:valAx>
        <c:axId val="1006016000"/>
        <c:scaling>
          <c:orientation val="minMax"/>
          <c:max val="6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Gene expression level</a:t>
                </a:r>
                <a:endParaRPr lang="ko-KR" dirty="0"/>
              </a:p>
            </c:rich>
          </c:tx>
          <c:layout>
            <c:manualLayout>
              <c:xMode val="edge"/>
              <c:yMode val="edge"/>
              <c:x val="2.3263258127829922E-2"/>
              <c:y val="0.224658604276736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00275680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150286635962612"/>
          <c:y val="4.85809041420973E-2"/>
          <c:w val="0.13875325987679513"/>
          <c:h val="0.138608535470559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043643783172735E-2"/>
          <c:y val="4.152058440375142E-2"/>
          <c:w val="0.88584022026620046"/>
          <c:h val="0.86407906694494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B vs IRM'!$C$2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BB vs IRM'!$B$22:$B$26</c:f>
              <c:strCache>
                <c:ptCount val="5"/>
                <c:pt idx="0">
                  <c:v>B3.21</c:v>
                </c:pt>
                <c:pt idx="1">
                  <c:v>B3.22</c:v>
                </c:pt>
                <c:pt idx="2">
                  <c:v>B4.22</c:v>
                </c:pt>
                <c:pt idx="3">
                  <c:v>B5.21</c:v>
                </c:pt>
                <c:pt idx="4">
                  <c:v>B6.21</c:v>
                </c:pt>
              </c:strCache>
            </c:strRef>
          </c:cat>
          <c:val>
            <c:numRef>
              <c:f>'BB vs IRM'!$C$22:$C$26</c:f>
              <c:numCache>
                <c:formatCode>General</c:formatCode>
                <c:ptCount val="5"/>
                <c:pt idx="0">
                  <c:v>1.2069806220273378</c:v>
                </c:pt>
                <c:pt idx="1">
                  <c:v>1.4838143463087548</c:v>
                </c:pt>
                <c:pt idx="2">
                  <c:v>3.516209385028457</c:v>
                </c:pt>
                <c:pt idx="3">
                  <c:v>2.6553324244869643</c:v>
                </c:pt>
                <c:pt idx="4">
                  <c:v>-0.334943153561997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C4-9849-A446-D45C03230A52}"/>
            </c:ext>
          </c:extLst>
        </c:ser>
        <c:ser>
          <c:idx val="1"/>
          <c:order val="1"/>
          <c:tx>
            <c:strRef>
              <c:f>'BB vs IRM'!$D$21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BB vs IRM'!$B$22:$B$26</c:f>
              <c:strCache>
                <c:ptCount val="5"/>
                <c:pt idx="0">
                  <c:v>B3.21</c:v>
                </c:pt>
                <c:pt idx="1">
                  <c:v>B3.22</c:v>
                </c:pt>
                <c:pt idx="2">
                  <c:v>B4.22</c:v>
                </c:pt>
                <c:pt idx="3">
                  <c:v>B5.21</c:v>
                </c:pt>
                <c:pt idx="4">
                  <c:v>B6.21</c:v>
                </c:pt>
              </c:strCache>
            </c:strRef>
          </c:cat>
          <c:val>
            <c:numRef>
              <c:f>'BB vs IRM'!$D$22:$D$26</c:f>
              <c:numCache>
                <c:formatCode>General</c:formatCode>
                <c:ptCount val="5"/>
                <c:pt idx="0">
                  <c:v>1.24379800956616</c:v>
                </c:pt>
                <c:pt idx="1">
                  <c:v>1.24379800956616</c:v>
                </c:pt>
                <c:pt idx="2">
                  <c:v>7.7815043756300897</c:v>
                </c:pt>
                <c:pt idx="3">
                  <c:v>2.24566918237071</c:v>
                </c:pt>
                <c:pt idx="4">
                  <c:v>-0.70615681384357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C4-9849-A446-D45C03230A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3457839"/>
        <c:axId val="793459087"/>
      </c:barChart>
      <c:catAx>
        <c:axId val="7934578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93459087"/>
        <c:crosses val="autoZero"/>
        <c:auto val="1"/>
        <c:lblAlgn val="ctr"/>
        <c:lblOffset val="100"/>
        <c:noMultiLvlLbl val="0"/>
      </c:catAx>
      <c:valAx>
        <c:axId val="793459087"/>
        <c:scaling>
          <c:orientation val="minMax"/>
          <c:max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Gene expression level</a:t>
                </a:r>
              </a:p>
            </c:rich>
          </c:tx>
          <c:layout>
            <c:manualLayout>
              <c:xMode val="edge"/>
              <c:yMode val="edge"/>
              <c:x val="2.2306816344257633E-2"/>
              <c:y val="0.390752778978543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934578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069330075270421"/>
          <c:y val="3.1698548721248207E-2"/>
          <c:w val="0.14353500858401275"/>
          <c:h val="0.1352120716386434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6A8E11-A731-5044-8449-95AE6E365895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ore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25815E-7626-3F48-B0C7-A9433BDBE2A7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396109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883758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721565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556550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31480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014429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25697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746667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266825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734265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72221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/>
              <a:t>그림을 추가하려면 아이콘을 클릭하십시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921899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9B16C-2AC3-DC45-A3CD-CEAC662CE399}" type="datetimeFigureOut">
              <a:rPr kumimoji="1" lang="ko-Kore-KR" altLang="en-US" smtClean="0"/>
              <a:t>01/06/2023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DC47A-3882-544C-94D1-2A9C8F3A364D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978568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DA83AF1E-A2CB-3742-B9A4-3AC29D124A5E}"/>
              </a:ext>
            </a:extLst>
          </p:cNvPr>
          <p:cNvSpPr/>
          <p:nvPr/>
        </p:nvSpPr>
        <p:spPr>
          <a:xfrm>
            <a:off x="1019397" y="1142118"/>
            <a:ext cx="5036846" cy="4412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t"/>
          <a:lstStyle/>
          <a:p>
            <a:pPr>
              <a:lnSpc>
                <a:spcPct val="150000"/>
              </a:lnSpc>
            </a:pPr>
            <a:r>
              <a:rPr lang="en-US" altLang="ko-KR" sz="11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sz="11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 bassiana </a:t>
            </a:r>
            <a:r>
              <a:rPr lang="en-US" altLang="ko-KR" sz="11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EF-410</a:t>
            </a:r>
            <a:endParaRPr lang="ko-KR" altLang="en-US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67BA7912-DFD0-416F-951E-366220529CB1}"/>
              </a:ext>
            </a:extLst>
          </p:cNvPr>
          <p:cNvSpPr/>
          <p:nvPr/>
        </p:nvSpPr>
        <p:spPr>
          <a:xfrm>
            <a:off x="1004514" y="10078395"/>
            <a:ext cx="6792977" cy="3911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t"/>
          <a:lstStyle/>
          <a:p>
            <a:pPr>
              <a:lnSpc>
                <a:spcPct val="150000"/>
              </a:lnSpc>
            </a:pP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 Fig. Validation for RNA-seq analysis by </a:t>
            </a:r>
            <a:r>
              <a:rPr lang="en-US" altLang="ko-KR" sz="1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ko-KR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PCR.</a:t>
            </a:r>
            <a:endParaRPr lang="ko-KR" altLang="en-US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EA91D5AE-EFE7-4732-A7C8-CCD834F33787}"/>
              </a:ext>
            </a:extLst>
          </p:cNvPr>
          <p:cNvSpPr/>
          <p:nvPr/>
        </p:nvSpPr>
        <p:spPr>
          <a:xfrm>
            <a:off x="1025750" y="5526147"/>
            <a:ext cx="3798042" cy="3180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t"/>
          <a:lstStyle/>
          <a:p>
            <a:pPr>
              <a:lnSpc>
                <a:spcPct val="150000"/>
              </a:lnSpc>
            </a:pPr>
            <a:r>
              <a:rPr lang="en-US" altLang="ko-KR" sz="11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Red mite</a:t>
            </a:r>
            <a:endParaRPr lang="ko-KR" altLang="en-US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차트 8">
            <a:extLst>
              <a:ext uri="{FF2B5EF4-FFF2-40B4-BE49-F238E27FC236}">
                <a16:creationId xmlns:a16="http://schemas.microsoft.com/office/drawing/2014/main" id="{A4079004-AF0E-4389-A824-F0CFF0FC1F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1954810"/>
              </p:ext>
            </p:extLst>
          </p:nvPr>
        </p:nvGraphicFramePr>
        <p:xfrm>
          <a:off x="563649" y="5937056"/>
          <a:ext cx="6432375" cy="3766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차트 9">
            <a:extLst>
              <a:ext uri="{FF2B5EF4-FFF2-40B4-BE49-F238E27FC236}">
                <a16:creationId xmlns:a16="http://schemas.microsoft.com/office/drawing/2014/main" id="{F9E9F775-C5A0-4287-8598-43A203F8FD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0224552"/>
              </p:ext>
            </p:extLst>
          </p:nvPr>
        </p:nvGraphicFramePr>
        <p:xfrm>
          <a:off x="539836" y="1596693"/>
          <a:ext cx="6456188" cy="3391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794359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10</TotalTime>
  <Words>28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Jong-Cheol</dc:creator>
  <cp:lastModifiedBy>김재수</cp:lastModifiedBy>
  <cp:revision>17</cp:revision>
  <dcterms:created xsi:type="dcterms:W3CDTF">2021-12-20T02:14:37Z</dcterms:created>
  <dcterms:modified xsi:type="dcterms:W3CDTF">2023-01-06T05:01:26Z</dcterms:modified>
</cp:coreProperties>
</file>